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6" d="100"/>
          <a:sy n="66" d="100"/>
        </p:scale>
        <p:origin x="-211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606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772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290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69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31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862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425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204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077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77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532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C5DCB-EBDC-0F4F-AA78-778F812987F6}" type="datetimeFigureOut">
              <a:rPr lang="en-US" smtClean="0"/>
              <a:t>10/2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DE0A6-D58F-9046-9E4D-0FECDD81B6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113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8052" y="4953000"/>
            <a:ext cx="499108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etic study of caspase-8 activity in delta-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cotrienol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A549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orde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acquire the most optimum treatment time point for determining the caspase-8 initiation, a kinetic study was carried out in A549 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ing delta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cotrien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MIC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 µ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µM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µM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µM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for different time interval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.e. 0 h, 0.5 h, 1 h, 2 h and 3 h. The 1-h incubation period was chosen for subsequent evaluation of cellular caspase-8 activity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: minimum inhibitory concentration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7759" y="982125"/>
            <a:ext cx="5291667" cy="31961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8089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06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 Wen Lim</dc:creator>
  <cp:lastModifiedBy>SANDY LOH HWEI SAN</cp:lastModifiedBy>
  <cp:revision>8</cp:revision>
  <dcterms:created xsi:type="dcterms:W3CDTF">2014-10-20T10:55:33Z</dcterms:created>
  <dcterms:modified xsi:type="dcterms:W3CDTF">2014-10-23T10:53:39Z</dcterms:modified>
</cp:coreProperties>
</file>